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32588" cy="98567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D85431-46AF-41EA-8C76-1A0A1F6DFFD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250886-148F-4A03-A558-917A562103C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3D2495-5EAF-4D2B-8650-B70FDAE7618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C628D7-BA68-49D2-A611-805E43C84E6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7AA2D0-C45E-4FD7-B920-02BC3E0404B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E02E11-A91E-467D-BE6B-B88E237D7AF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8CA078-A6C4-4ED0-8825-6CA2C8727F7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8ADDDF-C590-49FA-974B-78464124A82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25760E-3FB8-4A59-AB1D-74EF66FF6F1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64FC63-CA0A-4330-878D-7997481834F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3F193C-7B36-44A4-84E3-9B3DB053AE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4BFB7F-8E99-422F-AA75-97E286B27F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D5BA058-8818-4147-B62B-082F1DEE025A}" type="slidenum"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4797360" y="4398840"/>
            <a:ext cx="367200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E" sz="1000" spc="-1" strike="noStrike">
                <a:solidFill>
                  <a:srgbClr val="000000"/>
                </a:solidFill>
                <a:latin typeface="Arial"/>
              </a:rPr>
              <a:t>+PGE</a:t>
            </a:r>
            <a:r>
              <a:rPr b="1" lang="en-IE" sz="10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1" lang="en-IE" sz="800" spc="-1" strike="noStrike">
                <a:solidFill>
                  <a:srgbClr val="000000"/>
                </a:solidFill>
                <a:latin typeface="Arial"/>
              </a:rPr>
              <a:t>(1</a:t>
            </a:r>
            <a:r>
              <a:rPr b="1" lang="en-IE" sz="8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1" lang="en-IE" sz="800" spc="-1" strike="noStrike">
                <a:solidFill>
                  <a:srgbClr val="000000"/>
                </a:solidFill>
                <a:latin typeface="Arial"/>
              </a:rPr>
              <a:t>M)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757080" y="1979640"/>
            <a:ext cx="6481800" cy="3025800"/>
            <a:chOff x="757080" y="1979640"/>
            <a:chExt cx="6481800" cy="3025800"/>
          </a:xfrm>
        </p:grpSpPr>
        <p:graphicFrame>
          <p:nvGraphicFramePr>
            <p:cNvPr id="43" name=""/>
            <p:cNvGraphicFramePr/>
            <p:nvPr/>
          </p:nvGraphicFramePr>
          <p:xfrm>
            <a:off x="1765080" y="2124000"/>
            <a:ext cx="4197240" cy="2220840"/>
          </p:xfrm>
          <a:graphic>
            <a:graphicData uri="http://schemas.openxmlformats.org/presentationml/2006/ole">
              <p:oleObj progId="Excel.Sheet.12" r:id="rId1" spid="">
                <p:embed/>
                <p:pic>
                  <p:nvPicPr>
                    <p:cNvPr id="44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1765080" y="2124000"/>
                      <a:ext cx="4197240" cy="22208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45" name=""/>
            <p:cNvSpPr/>
            <p:nvPr/>
          </p:nvSpPr>
          <p:spPr>
            <a:xfrm>
              <a:off x="2197080" y="4255920"/>
              <a:ext cx="4176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E" sz="1000" spc="-1" strike="noStrike">
                  <a:solidFill>
                    <a:srgbClr val="000000"/>
                  </a:solidFill>
                  <a:latin typeface="Arial"/>
                </a:rPr>
                <a:t>Control    SC236</a:t>
              </a:r>
              <a:r>
                <a:rPr b="1" lang="en-IE" sz="800" spc="-1" strike="noStrike">
                  <a:solidFill>
                    <a:srgbClr val="000000"/>
                  </a:solidFill>
                  <a:latin typeface="Arial"/>
                </a:rPr>
                <a:t>(5</a:t>
              </a:r>
              <a:r>
                <a:rPr b="1" lang="en-IE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1" lang="en-IE" sz="800" spc="-1" strike="noStrike">
                  <a:solidFill>
                    <a:srgbClr val="000000"/>
                  </a:solidFill>
                  <a:latin typeface="Arial"/>
                </a:rPr>
                <a:t>M)</a:t>
              </a:r>
              <a:r>
                <a:rPr b="1" lang="en-IE" sz="1000" spc="-1" strike="noStrike">
                  <a:solidFill>
                    <a:srgbClr val="000000"/>
                  </a:solidFill>
                  <a:latin typeface="Arial"/>
                </a:rPr>
                <a:t>  SC236</a:t>
              </a:r>
              <a:r>
                <a:rPr b="1" lang="en-IE" sz="800" spc="-1" strike="noStrike">
                  <a:solidFill>
                    <a:srgbClr val="000000"/>
                  </a:solidFill>
                  <a:latin typeface="Arial"/>
                </a:rPr>
                <a:t>(5</a:t>
              </a:r>
              <a:r>
                <a:rPr b="1" lang="en-IE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1" lang="en-IE" sz="800" spc="-1" strike="noStrike">
                  <a:solidFill>
                    <a:srgbClr val="000000"/>
                  </a:solidFill>
                  <a:latin typeface="Arial"/>
                </a:rPr>
                <a:t>M)</a:t>
              </a:r>
              <a:r>
                <a:rPr b="1" lang="en-IE" sz="1000" spc="-1" strike="noStrike">
                  <a:solidFill>
                    <a:srgbClr val="000000"/>
                  </a:solidFill>
                  <a:latin typeface="Arial"/>
                </a:rPr>
                <a:t>   SC236</a:t>
              </a:r>
              <a:r>
                <a:rPr b="1" lang="en-IE" sz="800" spc="-1" strike="noStrike">
                  <a:solidFill>
                    <a:srgbClr val="000000"/>
                  </a:solidFill>
                  <a:latin typeface="Arial"/>
                </a:rPr>
                <a:t>(25</a:t>
              </a:r>
              <a:r>
                <a:rPr b="1" lang="en-IE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1" lang="en-IE" sz="800" spc="-1" strike="noStrike">
                  <a:solidFill>
                    <a:srgbClr val="000000"/>
                  </a:solidFill>
                  <a:latin typeface="Arial"/>
                </a:rPr>
                <a:t>M)</a:t>
              </a:r>
              <a:r>
                <a:rPr b="1" lang="en-IE" sz="1000" spc="-1" strike="noStrike">
                  <a:solidFill>
                    <a:srgbClr val="000000"/>
                  </a:solidFill>
                  <a:latin typeface="Arial"/>
                </a:rPr>
                <a:t>  SC236</a:t>
              </a:r>
              <a:r>
                <a:rPr b="1" lang="en-IE" sz="800" spc="-1" strike="noStrike">
                  <a:solidFill>
                    <a:srgbClr val="000000"/>
                  </a:solidFill>
                  <a:latin typeface="Arial"/>
                </a:rPr>
                <a:t>(25</a:t>
              </a:r>
              <a:r>
                <a:rPr b="1" lang="en-IE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1" lang="en-IE" sz="800" spc="-1" strike="noStrike">
                  <a:solidFill>
                    <a:srgbClr val="000000"/>
                  </a:solidFill>
                  <a:latin typeface="Arial"/>
                </a:rPr>
                <a:t>M)</a:t>
              </a:r>
              <a:r>
                <a:rPr b="1" lang="en-IE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3566880" y="4398840"/>
              <a:ext cx="3672000" cy="267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E" sz="1000" spc="-1" strike="noStrike">
                  <a:solidFill>
                    <a:srgbClr val="000000"/>
                  </a:solidFill>
                  <a:latin typeface="Arial"/>
                </a:rPr>
                <a:t>+PGE</a:t>
              </a:r>
              <a:r>
                <a:rPr b="1" lang="en-IE" sz="1000" spc="-1" strike="noStrike" baseline="-25000">
                  <a:solidFill>
                    <a:srgbClr val="000000"/>
                  </a:solidFill>
                  <a:latin typeface="Arial"/>
                </a:rPr>
                <a:t>2</a:t>
              </a:r>
              <a:r>
                <a:rPr b="1" lang="en-IE" sz="800" spc="-1" strike="noStrike">
                  <a:solidFill>
                    <a:srgbClr val="000000"/>
                  </a:solidFill>
                  <a:latin typeface="Arial"/>
                </a:rPr>
                <a:t>(1</a:t>
              </a:r>
              <a:r>
                <a:rPr b="1" lang="en-IE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1" lang="en-IE" sz="800" spc="-1" strike="noStrike">
                  <a:solidFill>
                    <a:srgbClr val="000000"/>
                  </a:solidFill>
                  <a:latin typeface="Arial"/>
                </a:rPr>
                <a:t>M)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757080" y="2916360"/>
              <a:ext cx="1152360" cy="630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E" sz="1000" spc="-1" strike="noStrike">
                  <a:solidFill>
                    <a:srgbClr val="000000"/>
                  </a:solidFill>
                  <a:latin typeface="Arial"/>
                </a:rPr>
                <a:t>BrdU Incorporation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E" sz="1000" spc="-1" strike="noStrike">
                  <a:solidFill>
                    <a:srgbClr val="000000"/>
                  </a:solidFill>
                  <a:latin typeface="Arial"/>
                </a:rPr>
                <a:t>(Absorbance)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2485800" y="2411280"/>
              <a:ext cx="719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3349440" y="2411280"/>
              <a:ext cx="647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2485800" y="2411280"/>
              <a:ext cx="0" cy="144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3205080" y="2411280"/>
              <a:ext cx="0" cy="289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3349440" y="2411280"/>
              <a:ext cx="0" cy="289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3997080" y="2411280"/>
              <a:ext cx="0" cy="144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2485800" y="2268360"/>
              <a:ext cx="2232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4717800" y="2268360"/>
              <a:ext cx="0" cy="863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2485800" y="2268360"/>
              <a:ext cx="0" cy="71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2557440" y="2411280"/>
              <a:ext cx="576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IE" sz="1000" spc="-1" strike="noStrike">
                  <a:solidFill>
                    <a:srgbClr val="000000"/>
                  </a:solidFill>
                  <a:latin typeface="Arial"/>
                </a:rPr>
                <a:t>p&lt;0.05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3062160" y="4759200"/>
              <a:ext cx="576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IE" sz="1000" spc="-1" strike="noStrike">
                  <a:solidFill>
                    <a:srgbClr val="000000"/>
                  </a:solidFill>
                  <a:latin typeface="Arial"/>
                </a:rPr>
                <a:t>ns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3349440" y="2411280"/>
              <a:ext cx="576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IE" sz="1000" spc="-1" strike="noStrike">
                  <a:solidFill>
                    <a:srgbClr val="000000"/>
                  </a:solidFill>
                  <a:latin typeface="Arial"/>
                </a:rPr>
                <a:t>p&lt;0.05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3349440" y="1979640"/>
              <a:ext cx="576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IE" sz="1000" spc="-1" strike="noStrike">
                  <a:solidFill>
                    <a:srgbClr val="000000"/>
                  </a:solidFill>
                  <a:latin typeface="Arial"/>
                </a:rPr>
                <a:t>p&lt;0.01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2485800" y="4788000"/>
              <a:ext cx="1440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"/>
            <p:cNvSpPr/>
            <p:nvPr/>
          </p:nvSpPr>
          <p:spPr>
            <a:xfrm flipV="1">
              <a:off x="2485800" y="4643280"/>
              <a:ext cx="0" cy="144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" name=""/>
            <p:cNvSpPr/>
            <p:nvPr/>
          </p:nvSpPr>
          <p:spPr>
            <a:xfrm flipV="1">
              <a:off x="3925800" y="4643280"/>
              <a:ext cx="0" cy="144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4717800" y="4788000"/>
              <a:ext cx="792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" name=""/>
            <p:cNvSpPr/>
            <p:nvPr/>
          </p:nvSpPr>
          <p:spPr>
            <a:xfrm flipV="1">
              <a:off x="4717800" y="4643280"/>
              <a:ext cx="0" cy="144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" name=""/>
            <p:cNvSpPr/>
            <p:nvPr/>
          </p:nvSpPr>
          <p:spPr>
            <a:xfrm flipV="1">
              <a:off x="5510160" y="4643280"/>
              <a:ext cx="0" cy="144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4933800" y="4759200"/>
              <a:ext cx="576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IE" sz="1000" spc="-1" strike="noStrike">
                  <a:solidFill>
                    <a:srgbClr val="000000"/>
                  </a:solidFill>
                  <a:latin typeface="Arial"/>
                </a:rPr>
                <a:t>ns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68" name=""/>
          <p:cNvSpPr/>
          <p:nvPr/>
        </p:nvSpPr>
        <p:spPr>
          <a:xfrm>
            <a:off x="685800" y="5651640"/>
            <a:ext cx="5840280" cy="85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000" spc="-1" strike="noStrike">
                <a:solidFill>
                  <a:srgbClr val="000000"/>
                </a:solidFill>
                <a:latin typeface="Times New Roman"/>
              </a:rPr>
              <a:t>Supplementary Figure 1.  </a:t>
            </a:r>
            <a:r>
              <a:rPr b="1" lang="en-IE" sz="1000" spc="-1" strike="noStrike">
                <a:solidFill>
                  <a:srgbClr val="000000"/>
                </a:solidFill>
                <a:latin typeface="Times New Roman"/>
              </a:rPr>
              <a:t>The effect of cycloxygenase-2 inhibition on HCA7 cell proliferation</a:t>
            </a:r>
            <a:r>
              <a:rPr b="0" lang="en-IE" sz="1000" spc="-1" strike="noStrike">
                <a:solidFill>
                  <a:srgbClr val="000000"/>
                </a:solidFill>
                <a:latin typeface="Times New Roman"/>
              </a:rPr>
              <a:t>. The results show the extent of BrdU incorporation (absorbance, y-axis) in HCA7 cells following treatment for 24 hours under the conditions outlined on the x-axis. The results reflect the mean +/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 standard error for n=3. One way ANOVA suggested a significant effect of treatment (p=0.0001). The differences between groups was then assessed by the bonferroni multiple comparisons test; p values are as shown.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0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4-22T19:24:48Z</dcterms:created>
  <dc:creator/>
  <dc:description/>
  <dc:language>en-US</dc:language>
  <cp:lastModifiedBy>wsadmin</cp:lastModifiedBy>
  <cp:lastPrinted>2009-05-15T18:43:25Z</cp:lastPrinted>
  <dcterms:modified xsi:type="dcterms:W3CDTF">2009-05-15T18:43:32Z</dcterms:modified>
  <cp:revision>37</cp:revision>
  <dc:subject/>
  <dc:title>PowerPoint Presentation</dc:title>
</cp:coreProperties>
</file>